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29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55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F60968F-11E7-C4EA-31D6-208EF6F3646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9382210E-DB0A-CECF-91DA-A7000164C5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B64DC8D-1F9A-D5F4-2832-CEA49F15D7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9BE33-5056-49BB-80D5-4D30951FAE7B}" type="datetimeFigureOut">
              <a:rPr lang="ko-KR" altLang="en-US" smtClean="0"/>
              <a:t>2024-09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7D39D6F-4E4B-9B64-DF97-ED4458ABD8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637C0E0-4CF2-2AB7-D3ED-E9691F2C4B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B163E-B7B2-4086-BEF9-D83578DBF0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41751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6B76A13-B99B-C482-919F-E12F35EF23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B227E2A6-141C-D181-29A4-903966A909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90B49E3-F0B4-5833-7430-16DBFE0491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9BE33-5056-49BB-80D5-4D30951FAE7B}" type="datetimeFigureOut">
              <a:rPr lang="ko-KR" altLang="en-US" smtClean="0"/>
              <a:t>2024-09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4F7739E-D9DF-E913-E2D6-BDC59E636D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EA26988-777D-7DD4-2E0F-42D07FACE0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B163E-B7B2-4086-BEF9-D83578DBF0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84127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D3B49442-88C5-DA5B-F026-66E3DCC236F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F2ABC5BB-8D29-47FF-172D-EEEBEC40A5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0DA0F23-E2BE-093E-D53A-5126FAB8D2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9BE33-5056-49BB-80D5-4D30951FAE7B}" type="datetimeFigureOut">
              <a:rPr lang="ko-KR" altLang="en-US" smtClean="0"/>
              <a:t>2024-09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5EF8712-60A5-377D-0E92-3D68861FED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56944CE-3700-3CFD-9557-A2AD886CB3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B163E-B7B2-4086-BEF9-D83578DBF0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98890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2FA3249-C5B6-B76C-8C4F-DC9F1471C2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1FBDF65-2FCE-EA03-1B56-8BCE20B0329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7FF3A1A-A744-30AE-BC71-33490B4BC7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9BE33-5056-49BB-80D5-4D30951FAE7B}" type="datetimeFigureOut">
              <a:rPr lang="ko-KR" altLang="en-US" smtClean="0"/>
              <a:t>2024-09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2A9B40C-819E-314B-686E-93F6BF633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3A392C5-F60D-FC4F-E983-BBE550CAAD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B163E-B7B2-4086-BEF9-D83578DBF0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80196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9508B93-DFD8-5F0D-9BE8-DBA10E4150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B2D464E-F5E6-B90C-2626-B35B832C1A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8B82539-2DC4-D6B1-ED22-2E81604A47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9BE33-5056-49BB-80D5-4D30951FAE7B}" type="datetimeFigureOut">
              <a:rPr lang="ko-KR" altLang="en-US" smtClean="0"/>
              <a:t>2024-09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5DBC9F6-F4BE-3EEA-6B0E-99E72E86A9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69323AF-9BA2-9030-F889-24D5561284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B163E-B7B2-4086-BEF9-D83578DBF0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91720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4273815-25CA-F676-3355-B65878F336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41CF756-5395-2E02-ADCF-15C224A9C12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2A4BB4C-696D-0A8D-630B-0461588FA1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09AD272-FF3C-AD19-D948-844B8BD17F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9BE33-5056-49BB-80D5-4D30951FAE7B}" type="datetimeFigureOut">
              <a:rPr lang="ko-KR" altLang="en-US" smtClean="0"/>
              <a:t>2024-09-1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CB12B02-DD93-C029-12A6-B87BB49A13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23A1CC7-901C-FEEB-0B3C-299175476D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B163E-B7B2-4086-BEF9-D83578DBF0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9246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33B5A91-8D5F-D77D-D701-E93A84CB84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82050D0-24B3-BE2D-F058-FC8685C63E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0C7F4A03-0A64-672A-8245-591B0C459E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7A9284C8-C570-68BF-36C8-EDAAE54CF2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82D8D49A-8E15-39CF-66E6-B6BBADCE30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872C2E7D-E42B-A71A-3E25-C778946B6F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9BE33-5056-49BB-80D5-4D30951FAE7B}" type="datetimeFigureOut">
              <a:rPr lang="ko-KR" altLang="en-US" smtClean="0"/>
              <a:t>2024-09-10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A8BB3F33-CF8D-771A-55CF-CB00247232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A67E31BB-0224-FBC3-AEAF-A6E2606BEA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B163E-B7B2-4086-BEF9-D83578DBF0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3317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6388AA5-41FC-CB4D-A0AE-567068A007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FF8BAD58-E7DD-C486-9EBE-311AA4DE9D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9BE33-5056-49BB-80D5-4D30951FAE7B}" type="datetimeFigureOut">
              <a:rPr lang="ko-KR" altLang="en-US" smtClean="0"/>
              <a:t>2024-09-10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B9A22A0E-A4B4-8767-F9A9-AFC6218FFA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497ED831-6D4F-C66E-C130-21C883F295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B163E-B7B2-4086-BEF9-D83578DBF0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90643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8779EEF9-260A-F5E5-03A1-AB00EF4CF1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9BE33-5056-49BB-80D5-4D30951FAE7B}" type="datetimeFigureOut">
              <a:rPr lang="ko-KR" altLang="en-US" smtClean="0"/>
              <a:t>2024-09-10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8A354F73-6AE3-2C7F-DD23-D093A3B09C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4706F92D-DAC6-847E-87DE-E081C6E37A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B163E-B7B2-4086-BEF9-D83578DBF0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2792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4C2A7AE-6FEF-DB42-49FB-8DB9413A0E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43D101A-00AE-4B51-5C30-8131D8C9F77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C28765FD-7002-C5D8-8430-0DEE10AC65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D9C1A6B-3535-C8EF-2ECA-EB65A6F16F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9BE33-5056-49BB-80D5-4D30951FAE7B}" type="datetimeFigureOut">
              <a:rPr lang="ko-KR" altLang="en-US" smtClean="0"/>
              <a:t>2024-09-1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2A8375F-402B-5025-D386-77C65FEE7A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1191C12-F601-FC37-E77B-67DFBFAB81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B163E-B7B2-4086-BEF9-D83578DBF0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76693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F0ECF7C-6255-0E0B-62CE-ACAAAD978D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A3F472D2-E060-A986-3E57-07425EBB130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6DE928AC-2791-17BA-D0B8-83588D7B9F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00C3A82-9E1C-0731-F644-0842AFDE06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9BE33-5056-49BB-80D5-4D30951FAE7B}" type="datetimeFigureOut">
              <a:rPr lang="ko-KR" altLang="en-US" smtClean="0"/>
              <a:t>2024-09-1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98AD9D4-129F-CE64-69E5-13871A13D5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F9C0CC1-40E0-9633-1484-407B3D2049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B163E-B7B2-4086-BEF9-D83578DBF0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78807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8A6999DF-FEE7-AF8C-D81F-CF641FB7DA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90F96B0-77F7-22D1-482F-7B9FDDEEFF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98B4395-1ED4-A78F-6022-ED8A02DD02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59BE33-5056-49BB-80D5-4D30951FAE7B}" type="datetimeFigureOut">
              <a:rPr lang="ko-KR" altLang="en-US" smtClean="0"/>
              <a:t>2024-09-1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2699623-D583-0D9B-A85E-62470C038B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9DD1677-56EC-BC0C-7AAD-1614E7C79C4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3B163E-B7B2-4086-BEF9-D83578DBF0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503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960D99D1-BB72-8CF3-9DAD-D093D1E198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75148" y="1563065"/>
            <a:ext cx="2524887" cy="110451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CEA6444-3B77-81A6-4587-34DF883BA624}"/>
              </a:ext>
            </a:extLst>
          </p:cNvPr>
          <p:cNvSpPr txBox="1"/>
          <p:nvPr/>
        </p:nvSpPr>
        <p:spPr>
          <a:xfrm>
            <a:off x="3168225" y="1173740"/>
            <a:ext cx="15361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IL-1B</a:t>
            </a:r>
            <a:endParaRPr lang="ko-KR" altLang="en-US" sz="14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934E97F-E13D-57E1-32FD-D04467326D99}"/>
              </a:ext>
            </a:extLst>
          </p:cNvPr>
          <p:cNvSpPr txBox="1"/>
          <p:nvPr/>
        </p:nvSpPr>
        <p:spPr>
          <a:xfrm>
            <a:off x="3120152" y="2770018"/>
            <a:ext cx="15361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TNF-a</a:t>
            </a:r>
            <a:endParaRPr lang="ko-KR" altLang="en-US" sz="1400" b="1" dirty="0"/>
          </a:p>
        </p:txBody>
      </p:sp>
      <p:pic>
        <p:nvPicPr>
          <p:cNvPr id="7" name="그림 6">
            <a:extLst>
              <a:ext uri="{FF2B5EF4-FFF2-40B4-BE49-F238E27FC236}">
                <a16:creationId xmlns:a16="http://schemas.microsoft.com/office/drawing/2014/main" id="{AC6E51ED-C589-EF73-2ED1-8EE3322B5DE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72080" y="4671108"/>
            <a:ext cx="2524887" cy="102059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71D9C88-F071-F4A2-286A-BB87655DFAE6}"/>
              </a:ext>
            </a:extLst>
          </p:cNvPr>
          <p:cNvSpPr txBox="1"/>
          <p:nvPr/>
        </p:nvSpPr>
        <p:spPr>
          <a:xfrm>
            <a:off x="3072080" y="4323253"/>
            <a:ext cx="15361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err="1"/>
              <a:t>CagA</a:t>
            </a:r>
            <a:endParaRPr lang="ko-KR" altLang="en-US" sz="1400" b="1" dirty="0"/>
          </a:p>
        </p:txBody>
      </p:sp>
      <p:pic>
        <p:nvPicPr>
          <p:cNvPr id="9" name="그림 8">
            <a:extLst>
              <a:ext uri="{FF2B5EF4-FFF2-40B4-BE49-F238E27FC236}">
                <a16:creationId xmlns:a16="http://schemas.microsoft.com/office/drawing/2014/main" id="{8C679DAF-9325-6B83-97C9-A3A57BCCDEF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6000" y="1578053"/>
            <a:ext cx="2518791" cy="114047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E0867BE-12CD-0644-4D37-E68D7EBB956D}"/>
              </a:ext>
            </a:extLst>
          </p:cNvPr>
          <p:cNvSpPr txBox="1"/>
          <p:nvPr/>
        </p:nvSpPr>
        <p:spPr>
          <a:xfrm>
            <a:off x="6011617" y="1173740"/>
            <a:ext cx="15361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PI3K</a:t>
            </a:r>
            <a:endParaRPr lang="ko-KR" altLang="en-US" sz="1400" b="1" dirty="0"/>
          </a:p>
        </p:txBody>
      </p:sp>
      <p:pic>
        <p:nvPicPr>
          <p:cNvPr id="11" name="그림 10">
            <a:extLst>
              <a:ext uri="{FF2B5EF4-FFF2-40B4-BE49-F238E27FC236}">
                <a16:creationId xmlns:a16="http://schemas.microsoft.com/office/drawing/2014/main" id="{CC3EC837-C5BF-4B54-0B43-D30A79304C2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03057" y="3185845"/>
            <a:ext cx="2467261" cy="1192488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DEF3F194-8B88-DF50-54F7-B675C8148A8F}"/>
              </a:ext>
            </a:extLst>
          </p:cNvPr>
          <p:cNvSpPr txBox="1"/>
          <p:nvPr/>
        </p:nvSpPr>
        <p:spPr>
          <a:xfrm>
            <a:off x="6011617" y="2815068"/>
            <a:ext cx="15361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NF-kB</a:t>
            </a:r>
            <a:endParaRPr lang="ko-KR" altLang="en-US" sz="14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E73FAF6-ABD5-99E7-17BF-05E1FADCE86F}"/>
              </a:ext>
            </a:extLst>
          </p:cNvPr>
          <p:cNvSpPr txBox="1"/>
          <p:nvPr/>
        </p:nvSpPr>
        <p:spPr>
          <a:xfrm>
            <a:off x="3372717" y="1538780"/>
            <a:ext cx="25187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M   AGS  HP 10ng 50ng 100ng </a:t>
            </a:r>
            <a:endParaRPr lang="ko-KR" altLang="en-US" sz="1000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F88518A-FCA6-8815-24F9-44C74DB4FDEC}"/>
              </a:ext>
            </a:extLst>
          </p:cNvPr>
          <p:cNvSpPr txBox="1"/>
          <p:nvPr/>
        </p:nvSpPr>
        <p:spPr>
          <a:xfrm>
            <a:off x="6372796" y="1651262"/>
            <a:ext cx="25187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M   </a:t>
            </a:r>
            <a:r>
              <a:rPr lang="en-US" altLang="ko-KR" sz="800" b="1" dirty="0"/>
              <a:t>AGS  HP 10ng 50ng 100ng </a:t>
            </a:r>
            <a:endParaRPr lang="ko-KR" altLang="en-US" sz="800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51EF3D0-B191-9DFD-EA55-1F5EF2818A4D}"/>
              </a:ext>
            </a:extLst>
          </p:cNvPr>
          <p:cNvSpPr txBox="1"/>
          <p:nvPr/>
        </p:nvSpPr>
        <p:spPr>
          <a:xfrm>
            <a:off x="6379852" y="3159196"/>
            <a:ext cx="25187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M   AGS  HP 10ng 50ng 100ng </a:t>
            </a:r>
            <a:endParaRPr lang="ko-KR" altLang="en-US" sz="10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3971ED9-8B42-7C78-1230-CA0087B30464}"/>
              </a:ext>
            </a:extLst>
          </p:cNvPr>
          <p:cNvSpPr txBox="1"/>
          <p:nvPr/>
        </p:nvSpPr>
        <p:spPr>
          <a:xfrm>
            <a:off x="3120152" y="4669780"/>
            <a:ext cx="26348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M    AGS     HP     10ng    50ng  100ng </a:t>
            </a:r>
            <a:endParaRPr lang="ko-KR" altLang="en-US" sz="1000" b="1" dirty="0"/>
          </a:p>
        </p:txBody>
      </p:sp>
      <p:pic>
        <p:nvPicPr>
          <p:cNvPr id="17" name="그림 16">
            <a:extLst>
              <a:ext uri="{FF2B5EF4-FFF2-40B4-BE49-F238E27FC236}">
                <a16:creationId xmlns:a16="http://schemas.microsoft.com/office/drawing/2014/main" id="{77F15860-00B9-1700-B87C-967D137A0C0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043447" y="4768506"/>
            <a:ext cx="2501464" cy="1020597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E218C96A-38F5-B8D2-8DA5-55897D325064}"/>
              </a:ext>
            </a:extLst>
          </p:cNvPr>
          <p:cNvSpPr txBox="1"/>
          <p:nvPr/>
        </p:nvSpPr>
        <p:spPr>
          <a:xfrm>
            <a:off x="6201513" y="4762880"/>
            <a:ext cx="25187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M   AGS  HP 10ng 50ng 100ng </a:t>
            </a:r>
            <a:endParaRPr lang="ko-KR" altLang="en-US" sz="10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BB87545-23E0-B563-D874-CC06AB47E9E1}"/>
              </a:ext>
            </a:extLst>
          </p:cNvPr>
          <p:cNvSpPr txBox="1"/>
          <p:nvPr/>
        </p:nvSpPr>
        <p:spPr>
          <a:xfrm>
            <a:off x="6010936" y="4428420"/>
            <a:ext cx="15361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GAPDH</a:t>
            </a:r>
            <a:endParaRPr lang="ko-KR" altLang="en-US" sz="1400" b="1" dirty="0"/>
          </a:p>
        </p:txBody>
      </p:sp>
      <p:pic>
        <p:nvPicPr>
          <p:cNvPr id="26" name="그림 25">
            <a:extLst>
              <a:ext uri="{FF2B5EF4-FFF2-40B4-BE49-F238E27FC236}">
                <a16:creationId xmlns:a16="http://schemas.microsoft.com/office/drawing/2014/main" id="{62E202DB-CFFA-022B-A488-C2A986A3607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03212" y="3049428"/>
            <a:ext cx="2368976" cy="1211361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8031594F-4B31-AFB4-0BB8-D8EDC9DBDAFE}"/>
              </a:ext>
            </a:extLst>
          </p:cNvPr>
          <p:cNvSpPr txBox="1"/>
          <p:nvPr/>
        </p:nvSpPr>
        <p:spPr>
          <a:xfrm>
            <a:off x="3236242" y="3104280"/>
            <a:ext cx="25187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/>
              <a:t>      AGS  HP 10ng 50ng 100ng  M </a:t>
            </a:r>
            <a:endParaRPr lang="ko-KR" altLang="en-US" sz="1000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7445483-A263-445B-7D8A-4D68E7C412DA}"/>
              </a:ext>
            </a:extLst>
          </p:cNvPr>
          <p:cNvSpPr txBox="1"/>
          <p:nvPr/>
        </p:nvSpPr>
        <p:spPr>
          <a:xfrm>
            <a:off x="2753503" y="1845483"/>
            <a:ext cx="52718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35</a:t>
            </a:r>
          </a:p>
          <a:p>
            <a:r>
              <a:rPr lang="en-US" altLang="ko-KR" sz="1400" b="1" dirty="0"/>
              <a:t>25</a:t>
            </a:r>
            <a:endParaRPr lang="ko-KR" altLang="en-US" sz="1400" b="1" dirty="0"/>
          </a:p>
        </p:txBody>
      </p:sp>
      <p:sp>
        <p:nvSpPr>
          <p:cNvPr id="3" name="화살표: 오른쪽 2">
            <a:extLst>
              <a:ext uri="{FF2B5EF4-FFF2-40B4-BE49-F238E27FC236}">
                <a16:creationId xmlns:a16="http://schemas.microsoft.com/office/drawing/2014/main" id="{3FB11BB3-1014-4941-18C7-2140F0D8E504}"/>
              </a:ext>
            </a:extLst>
          </p:cNvPr>
          <p:cNvSpPr/>
          <p:nvPr/>
        </p:nvSpPr>
        <p:spPr>
          <a:xfrm>
            <a:off x="3203212" y="1931555"/>
            <a:ext cx="179579" cy="118047"/>
          </a:xfrm>
          <a:prstGeom prst="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8" name="화살표: 오른쪽 27">
            <a:extLst>
              <a:ext uri="{FF2B5EF4-FFF2-40B4-BE49-F238E27FC236}">
                <a16:creationId xmlns:a16="http://schemas.microsoft.com/office/drawing/2014/main" id="{FEE5ABC3-2B79-ABDA-4D14-FB80E24ABDCA}"/>
              </a:ext>
            </a:extLst>
          </p:cNvPr>
          <p:cNvSpPr/>
          <p:nvPr/>
        </p:nvSpPr>
        <p:spPr>
          <a:xfrm>
            <a:off x="3193138" y="2167430"/>
            <a:ext cx="179579" cy="137526"/>
          </a:xfrm>
          <a:prstGeom prst="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502FF05-C4CB-857E-AF9B-A83B23AE285B}"/>
              </a:ext>
            </a:extLst>
          </p:cNvPr>
          <p:cNvSpPr txBox="1"/>
          <p:nvPr/>
        </p:nvSpPr>
        <p:spPr>
          <a:xfrm>
            <a:off x="5857846" y="2357166"/>
            <a:ext cx="5271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75</a:t>
            </a:r>
            <a:endParaRPr lang="ko-KR" altLang="en-US" sz="1400" b="1" dirty="0"/>
          </a:p>
        </p:txBody>
      </p:sp>
      <p:sp>
        <p:nvSpPr>
          <p:cNvPr id="30" name="화살표: 오른쪽 29">
            <a:extLst>
              <a:ext uri="{FF2B5EF4-FFF2-40B4-BE49-F238E27FC236}">
                <a16:creationId xmlns:a16="http://schemas.microsoft.com/office/drawing/2014/main" id="{5C91CD46-08FC-5BAD-2B04-6FC7546596F2}"/>
              </a:ext>
            </a:extLst>
          </p:cNvPr>
          <p:cNvSpPr/>
          <p:nvPr/>
        </p:nvSpPr>
        <p:spPr>
          <a:xfrm>
            <a:off x="6189733" y="2427468"/>
            <a:ext cx="241978" cy="159704"/>
          </a:xfrm>
          <a:prstGeom prst="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6516B16-66C5-E52F-7DF3-62B118158490}"/>
              </a:ext>
            </a:extLst>
          </p:cNvPr>
          <p:cNvSpPr txBox="1"/>
          <p:nvPr/>
        </p:nvSpPr>
        <p:spPr>
          <a:xfrm>
            <a:off x="5662549" y="3268114"/>
            <a:ext cx="5271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35</a:t>
            </a:r>
          </a:p>
        </p:txBody>
      </p:sp>
      <p:sp>
        <p:nvSpPr>
          <p:cNvPr id="32" name="화살표: 왼쪽 31">
            <a:extLst>
              <a:ext uri="{FF2B5EF4-FFF2-40B4-BE49-F238E27FC236}">
                <a16:creationId xmlns:a16="http://schemas.microsoft.com/office/drawing/2014/main" id="{58BCC312-AFD6-FF31-CE5B-9F65AAD96567}"/>
              </a:ext>
            </a:extLst>
          </p:cNvPr>
          <p:cNvSpPr/>
          <p:nvPr/>
        </p:nvSpPr>
        <p:spPr>
          <a:xfrm>
            <a:off x="5468870" y="3360057"/>
            <a:ext cx="261126" cy="152121"/>
          </a:xfrm>
          <a:prstGeom prst="lef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B5B2566-C7C5-997B-B652-C088461AD5FF}"/>
              </a:ext>
            </a:extLst>
          </p:cNvPr>
          <p:cNvSpPr txBox="1"/>
          <p:nvPr/>
        </p:nvSpPr>
        <p:spPr>
          <a:xfrm>
            <a:off x="5820357" y="3467385"/>
            <a:ext cx="5271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75</a:t>
            </a:r>
            <a:endParaRPr lang="ko-KR" altLang="en-US" sz="1400" b="1" dirty="0"/>
          </a:p>
        </p:txBody>
      </p:sp>
      <p:sp>
        <p:nvSpPr>
          <p:cNvPr id="34" name="화살표: 오른쪽 33">
            <a:extLst>
              <a:ext uri="{FF2B5EF4-FFF2-40B4-BE49-F238E27FC236}">
                <a16:creationId xmlns:a16="http://schemas.microsoft.com/office/drawing/2014/main" id="{6605B6A2-9170-677A-F331-E123C3C4D343}"/>
              </a:ext>
            </a:extLst>
          </p:cNvPr>
          <p:cNvSpPr/>
          <p:nvPr/>
        </p:nvSpPr>
        <p:spPr>
          <a:xfrm>
            <a:off x="6121484" y="3572197"/>
            <a:ext cx="241978" cy="159704"/>
          </a:xfrm>
          <a:prstGeom prst="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2875B9F-EF46-FDFA-DDB7-BAC3B3B44A79}"/>
              </a:ext>
            </a:extLst>
          </p:cNvPr>
          <p:cNvSpPr txBox="1"/>
          <p:nvPr/>
        </p:nvSpPr>
        <p:spPr>
          <a:xfrm>
            <a:off x="2528720" y="5116989"/>
            <a:ext cx="5271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110</a:t>
            </a:r>
            <a:endParaRPr lang="ko-KR" altLang="en-US" sz="1400" b="1" dirty="0"/>
          </a:p>
        </p:txBody>
      </p:sp>
      <p:sp>
        <p:nvSpPr>
          <p:cNvPr id="36" name="화살표: 오른쪽 35">
            <a:extLst>
              <a:ext uri="{FF2B5EF4-FFF2-40B4-BE49-F238E27FC236}">
                <a16:creationId xmlns:a16="http://schemas.microsoft.com/office/drawing/2014/main" id="{D35B78B3-FCB0-8842-A009-A37A36112A32}"/>
              </a:ext>
            </a:extLst>
          </p:cNvPr>
          <p:cNvSpPr/>
          <p:nvPr/>
        </p:nvSpPr>
        <p:spPr>
          <a:xfrm>
            <a:off x="3015552" y="5186604"/>
            <a:ext cx="179579" cy="137526"/>
          </a:xfrm>
          <a:prstGeom prst="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C860418-D17C-6576-8634-51D92530F49E}"/>
              </a:ext>
            </a:extLst>
          </p:cNvPr>
          <p:cNvSpPr txBox="1"/>
          <p:nvPr/>
        </p:nvSpPr>
        <p:spPr>
          <a:xfrm>
            <a:off x="5797591" y="5260749"/>
            <a:ext cx="5271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/>
              <a:t>35</a:t>
            </a:r>
            <a:endParaRPr lang="ko-KR" altLang="en-US" sz="1400" b="1" dirty="0"/>
          </a:p>
        </p:txBody>
      </p:sp>
      <p:sp>
        <p:nvSpPr>
          <p:cNvPr id="38" name="화살표: 오른쪽 37">
            <a:extLst>
              <a:ext uri="{FF2B5EF4-FFF2-40B4-BE49-F238E27FC236}">
                <a16:creationId xmlns:a16="http://schemas.microsoft.com/office/drawing/2014/main" id="{9E1E60C1-7641-4EE5-E890-3215A4DBD402}"/>
              </a:ext>
            </a:extLst>
          </p:cNvPr>
          <p:cNvSpPr/>
          <p:nvPr/>
        </p:nvSpPr>
        <p:spPr>
          <a:xfrm>
            <a:off x="6130818" y="5334786"/>
            <a:ext cx="241978" cy="159704"/>
          </a:xfrm>
          <a:prstGeom prst="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37918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50</Words>
  <Application>Microsoft Office PowerPoint</Application>
  <PresentationFormat>와이드스크린</PresentationFormat>
  <Paragraphs>1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nknown</dc:creator>
  <cp:lastModifiedBy>samsung</cp:lastModifiedBy>
  <cp:revision>3</cp:revision>
  <dcterms:created xsi:type="dcterms:W3CDTF">2024-09-02T05:19:35Z</dcterms:created>
  <dcterms:modified xsi:type="dcterms:W3CDTF">2024-09-10T03:06:54Z</dcterms:modified>
</cp:coreProperties>
</file>